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40DC9-051F-4DDF-BD65-60F1F04337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77546-B6E8-4EB7-8E36-D07F1A67B6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E7AF0-DE16-4D54-8684-99A40E0877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E98BF-5732-47C6-9676-BC3762C8210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3CCF6-1679-4ED2-B8FD-FD5850B20A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A0F31-E502-4EC8-A4FF-298CF90465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D44AA-8DD7-48A2-AC8E-BC8D514601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00C2A-3AAD-4C21-98D3-47827CBD92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4B5B8-8567-444B-9616-B379795B17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06D5D-63A7-4884-8554-68C240A62F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3DA0F-60C8-425B-93F7-18B140188C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AE7E58-C571-4003-9BC6-05AE52A8F3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D494BD-D74B-4EB2-B922-9096F93EF82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536400" y="2313000"/>
            <a:ext cx="3748320" cy="21654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074680" y="2725560"/>
            <a:ext cx="307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55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271880" y="2583000"/>
            <a:ext cx="6620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ffffff"/>
                </a:solidFill>
                <a:latin typeface="Arial"/>
              </a:rPr>
              <a:t>Compl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ffffff"/>
                </a:solidFill>
                <a:latin typeface="Arial"/>
              </a:rPr>
              <a:t>firestor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611080" y="3006720"/>
            <a:ext cx="307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3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132000" y="2906640"/>
            <a:ext cx="6696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Compl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sawtoot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138040" y="3179880"/>
            <a:ext cx="307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881360" y="3417840"/>
            <a:ext cx="587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mpl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2"/>
          <a:stretch/>
        </p:blipFill>
        <p:spPr>
          <a:xfrm>
            <a:off x="5003640" y="2313000"/>
            <a:ext cx="3745080" cy="216540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6691320" y="2681280"/>
            <a:ext cx="48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42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162920" y="2487600"/>
            <a:ext cx="6620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ffffff"/>
                </a:solidFill>
                <a:latin typeface="Arial"/>
              </a:rPr>
              <a:t>Compl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ffffff"/>
                </a:solidFill>
                <a:latin typeface="Arial"/>
              </a:rPr>
              <a:t>firestor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348240" y="2997360"/>
            <a:ext cx="48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492880" y="3014640"/>
            <a:ext cx="587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mpl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022880" y="3078000"/>
            <a:ext cx="307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7329600" y="3181320"/>
            <a:ext cx="6696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Compl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sawtoot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065680" y="4724280"/>
            <a:ext cx="68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IB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6447240" y="4724280"/>
            <a:ext cx="857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Arial"/>
              </a:rPr>
              <a:t>nIB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772040" y="6308640"/>
            <a:ext cx="1119960" cy="34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7920" rIns="97920" tIns="48960" bIns="48960" anchor="t">
            <a:spAutoFit/>
          </a:bodyPr>
          <a:p>
            <a:pPr>
              <a:tabLst>
                <a:tab algn="l" pos="0"/>
                <a:tab algn="l" pos="979560"/>
                <a:tab algn="l" pos="1959120"/>
                <a:tab algn="l" pos="2938320"/>
                <a:tab algn="l" pos="3917880"/>
                <a:tab algn="l" pos="4897440"/>
                <a:tab algn="l" pos="5877000"/>
                <a:tab algn="l" pos="6856560"/>
                <a:tab algn="l" pos="7835760"/>
                <a:tab algn="l" pos="8815320"/>
                <a:tab algn="l" pos="9794880"/>
                <a:tab algn="l" pos="1077444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9T16:07:10Z</dcterms:created>
  <dc:creator>FINETTIP</dc:creator>
  <dc:description/>
  <dc:language>en-US</dc:language>
  <cp:lastModifiedBy>Bertucci</cp:lastModifiedBy>
  <dcterms:modified xsi:type="dcterms:W3CDTF">2010-08-07T14:19:13Z</dcterms:modified>
  <cp:revision>16</cp:revision>
  <dc:subject/>
  <dc:title>Diapositive 1</dc:title>
</cp:coreProperties>
</file>